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3" d="100"/>
          <a:sy n="63" d="100"/>
        </p:scale>
        <p:origin x="780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A945CE3-F89B-B871-62DD-19A7F8FF717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F9D36E7F-BC5A-A385-15CE-31C8D6175D4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CBF6955-C8A1-0D58-4902-D96EA3C31F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3A77BF-3EDF-481F-BA7B-8D78D50CEB97}" type="datetimeFigureOut">
              <a:rPr lang="zh-CN" altLang="en-US" smtClean="0"/>
              <a:t>2022/10/2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B3228D2-A724-60DD-AD4A-09D481EC7F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AB2463A-25D4-28C0-A21D-CEEA89A12B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186250-B1A3-471F-AAB8-596C3617868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543899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98198ED-08BD-AE43-9FB1-2213D8A22D5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1285F8FE-585C-2DEB-AF68-6E7490A2569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681F3E0-1DA8-239E-3DF8-07B01E3926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3A77BF-3EDF-481F-BA7B-8D78D50CEB97}" type="datetimeFigureOut">
              <a:rPr lang="zh-CN" altLang="en-US" smtClean="0"/>
              <a:t>2022/10/2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60E25C6-E6D3-AED2-A22D-65D1933463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18E5590-D6E7-C890-31BB-160B6F5002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186250-B1A3-471F-AAB8-596C3617868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77777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61371B3C-4639-DA1D-938F-0E6B9DBCCD1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E3027CF2-C800-7790-FB13-1303613F484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F228DCA-6F23-5083-18FC-BE5F5319FF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3A77BF-3EDF-481F-BA7B-8D78D50CEB97}" type="datetimeFigureOut">
              <a:rPr lang="zh-CN" altLang="en-US" smtClean="0"/>
              <a:t>2022/10/2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49D606A-2BEE-E5A5-C0D5-8FEBDF14AE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060E60E-249C-2BA8-ED90-DD342E5794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186250-B1A3-471F-AAB8-596C3617868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98683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BD14E88-98EA-0253-6201-2B2231BF3F8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9C9C373D-5BEE-329B-60F2-74535EF5609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A04D70D-FA90-D97E-0DB8-4F16DD40F2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3A77BF-3EDF-481F-BA7B-8D78D50CEB97}" type="datetimeFigureOut">
              <a:rPr lang="zh-CN" altLang="en-US" smtClean="0"/>
              <a:t>2022/10/2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EC3529F-DD6D-661F-32B4-63A7183B8C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2D26F04-3EE0-4CA4-51DE-09F1B3E347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186250-B1A3-471F-AAB8-596C3617868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776039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519C988-E0B6-F181-B98A-A6BCD841B65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498E05D4-4F98-7C5E-9003-40A61BB4A2F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6F86BCD-96C9-0C06-2032-D49FDFC81E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3A77BF-3EDF-481F-BA7B-8D78D50CEB97}" type="datetimeFigureOut">
              <a:rPr lang="zh-CN" altLang="en-US" smtClean="0"/>
              <a:t>2022/10/2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7AFB8A2-7C59-51B3-761B-4661196289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28F128C-4022-9BF9-B100-D481FF6FB6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186250-B1A3-471F-AAB8-596C3617868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399269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FDAF75B-9679-5924-37C3-AF347D7A9F5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2558BC38-D479-C1F9-9153-EE07937FCC1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2D2EF3DE-2FE6-0C1E-AFB2-338AD07392E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2E39E313-F511-21CA-24B9-043A15A84B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3A77BF-3EDF-481F-BA7B-8D78D50CEB97}" type="datetimeFigureOut">
              <a:rPr lang="zh-CN" altLang="en-US" smtClean="0"/>
              <a:t>2022/10/2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8BF145BC-BB6E-82F1-BF18-3A6CB479B5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18BFE9EA-2B0E-812A-8E82-74D3E7D5E4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186250-B1A3-471F-AAB8-596C3617868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966790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E3763B6-0400-EBAD-9D78-70F1925F4F1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7B251023-ECD0-FAD8-CDFE-4531BF55F01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B1BAA3B3-F3EC-0A7D-692C-9570612D471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6E35644D-41B4-CAA6-301E-2B1130DE5CC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0BD4F204-60CC-42C3-7657-BCBFFDD9C29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EE443E0C-7F89-210D-8F99-64484D2DB0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3A77BF-3EDF-481F-BA7B-8D78D50CEB97}" type="datetimeFigureOut">
              <a:rPr lang="zh-CN" altLang="en-US" smtClean="0"/>
              <a:t>2022/10/27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4709FBC0-75F7-7130-F3EA-45AB2A92D8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16312730-971E-5F57-B163-FEE298D0F3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186250-B1A3-471F-AAB8-596C3617868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029262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1392F4C-5973-4BB2-F020-DEC334966DB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C9A6C7DE-1420-F822-78E7-F4DD5067C0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3A77BF-3EDF-481F-BA7B-8D78D50CEB97}" type="datetimeFigureOut">
              <a:rPr lang="zh-CN" altLang="en-US" smtClean="0"/>
              <a:t>2022/10/27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1CF0698B-1F7D-4878-9CE1-9B6F6B4DE9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E0F86CEA-1796-2C52-6533-3E2C67B012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186250-B1A3-471F-AAB8-596C3617868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678817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BD0D8886-5099-9D68-591B-7B2C5D9F0A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3A77BF-3EDF-481F-BA7B-8D78D50CEB97}" type="datetimeFigureOut">
              <a:rPr lang="zh-CN" altLang="en-US" smtClean="0"/>
              <a:t>2022/10/27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487769B4-38B6-750B-3E05-FBCAD8A1F8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82DA57A8-2EF8-57A1-86FA-21E4E474D1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186250-B1A3-471F-AAB8-596C3617868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685985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1C59B24-14DD-1677-C3E1-4E561F015C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2672823C-240C-9D30-96FC-DFFBDE60158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83F5C9C6-E22E-13BA-5B57-D5787444E17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D58E5BFB-1D9B-A5CA-CDA0-3AD9E62BD8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3A77BF-3EDF-481F-BA7B-8D78D50CEB97}" type="datetimeFigureOut">
              <a:rPr lang="zh-CN" altLang="en-US" smtClean="0"/>
              <a:t>2022/10/2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38E802D6-4D2E-03FB-A0F2-91C49F14C6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AA6F14A8-D470-B612-04E2-8228628114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186250-B1A3-471F-AAB8-596C3617868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584011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5F09389-BEEA-DE79-AD3C-E311D3D11FA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A279F38B-4B14-68DD-6D93-E197194E946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C6DE308E-BA66-3851-7631-BB7A72C41AE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9DC902F7-12DF-5EAF-D6B0-399BBF7148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3A77BF-3EDF-481F-BA7B-8D78D50CEB97}" type="datetimeFigureOut">
              <a:rPr lang="zh-CN" altLang="en-US" smtClean="0"/>
              <a:t>2022/10/2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E791489E-5B78-1745-8924-6913938B1E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C32DC1AC-2825-682E-A30D-402163DC81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186250-B1A3-471F-AAB8-596C3617868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780083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D70E6B8E-2095-3399-9A2F-0F4E9F8042E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3F83339C-9819-A5A1-E24D-1B6315D6D8E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1483A33-BE96-A19C-8434-D14A484D407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3A77BF-3EDF-481F-BA7B-8D78D50CEB97}" type="datetimeFigureOut">
              <a:rPr lang="zh-CN" altLang="en-US" smtClean="0"/>
              <a:t>2022/10/2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B02491F-07FD-97EB-FEFD-0AD03A09CDB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2467D46-9D09-8225-5B84-BD3E58DBCC8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186250-B1A3-471F-AAB8-596C3617868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343899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CEF477BD-13DA-E3BD-9BC8-026182993B6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57448" y="726009"/>
            <a:ext cx="8333954" cy="5316173"/>
          </a:xfrm>
          <a:prstGeom prst="rect">
            <a:avLst/>
          </a:prstGeom>
        </p:spPr>
      </p:pic>
      <p:sp>
        <p:nvSpPr>
          <p:cNvPr id="8" name="文本框 7">
            <a:extLst>
              <a:ext uri="{FF2B5EF4-FFF2-40B4-BE49-F238E27FC236}">
                <a16:creationId xmlns:a16="http://schemas.microsoft.com/office/drawing/2014/main" id="{B6FB8D97-D72C-3EF5-5450-DFC52F952E08}"/>
              </a:ext>
            </a:extLst>
          </p:cNvPr>
          <p:cNvSpPr txBox="1"/>
          <p:nvPr/>
        </p:nvSpPr>
        <p:spPr>
          <a:xfrm>
            <a:off x="5181668" y="3832269"/>
            <a:ext cx="6096680" cy="203132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800" kern="100" dirty="0">
                <a:effectLst/>
                <a:latin typeface="Arial" panose="020B0604020202020204" pitchFamily="34" charset="0"/>
                <a:ea typeface="宋体" panose="02010600030101010101" pitchFamily="2" charset="-122"/>
              </a:rPr>
              <a:t>Fig. S1 The original </a:t>
            </a:r>
            <a:r>
              <a:rPr lang="en-US" altLang="zh-CN" kern="100" dirty="0">
                <a:latin typeface="Arial" panose="020B0604020202020204" pitchFamily="34" charset="0"/>
                <a:ea typeface="宋体" panose="02010600030101010101" pitchFamily="2" charset="-122"/>
              </a:rPr>
              <a:t>blots of </a:t>
            </a:r>
            <a:r>
              <a:rPr lang="en-US" altLang="zh-CN" sz="1800" kern="100" dirty="0">
                <a:effectLst/>
                <a:latin typeface="Arial" panose="020B0604020202020204" pitchFamily="34" charset="0"/>
                <a:ea typeface="宋体" panose="02010600030101010101" pitchFamily="2" charset="-122"/>
              </a:rPr>
              <a:t>EMSA results in Fig. </a:t>
            </a:r>
            <a:r>
              <a:rPr lang="en-US" altLang="zh-CN" sz="1800" kern="100">
                <a:effectLst/>
                <a:latin typeface="Arial" panose="020B0604020202020204" pitchFamily="34" charset="0"/>
                <a:ea typeface="宋体" panose="02010600030101010101" pitchFamily="2" charset="-122"/>
              </a:rPr>
              <a:t>1B. </a:t>
            </a:r>
            <a:r>
              <a:rPr lang="en-US" altLang="zh-CN" sz="1800" kern="100" dirty="0">
                <a:effectLst/>
                <a:latin typeface="Arial" panose="020B0604020202020204" pitchFamily="34" charset="0"/>
                <a:ea typeface="宋体" panose="02010600030101010101" pitchFamily="2" charset="-122"/>
              </a:rPr>
              <a:t>Each lane contained 0.3 </a:t>
            </a:r>
            <a:r>
              <a:rPr lang="en-US" altLang="zh-CN" sz="1800" kern="100" dirty="0" err="1">
                <a:effectLst/>
                <a:latin typeface="Arial" panose="020B0604020202020204" pitchFamily="34" charset="0"/>
                <a:ea typeface="宋体" panose="02010600030101010101" pitchFamily="2" charset="-122"/>
              </a:rPr>
              <a:t>nM</a:t>
            </a:r>
            <a:r>
              <a:rPr lang="en-US" altLang="zh-CN" sz="1800" kern="100" dirty="0">
                <a:effectLst/>
                <a:latin typeface="Arial" panose="020B0604020202020204" pitchFamily="34" charset="0"/>
                <a:ea typeface="宋体" panose="02010600030101010101" pitchFamily="2" charset="-122"/>
              </a:rPr>
              <a:t> labeled probe. For the 5 lanes of </a:t>
            </a:r>
            <a:r>
              <a:rPr lang="en-US" altLang="zh-CN" kern="100" dirty="0">
                <a:latin typeface="Arial" panose="020B0604020202020204" pitchFamily="34" charset="0"/>
                <a:ea typeface="宋体" panose="02010600030101010101" pitchFamily="2" charset="-122"/>
              </a:rPr>
              <a:t>the EMSA of each gene promoter, l</a:t>
            </a:r>
            <a:r>
              <a:rPr lang="en-US" altLang="zh-CN" sz="1800" kern="100" dirty="0">
                <a:effectLst/>
                <a:latin typeface="Arial" panose="020B0604020202020204" pitchFamily="34" charset="0"/>
                <a:ea typeface="宋体" panose="02010600030101010101" pitchFamily="2" charset="-122"/>
              </a:rPr>
              <a:t>anes </a:t>
            </a:r>
            <a:r>
              <a:rPr lang="en-US" altLang="zh-CN" kern="100" dirty="0">
                <a:latin typeface="Arial" panose="020B0604020202020204" pitchFamily="34" charset="0"/>
                <a:ea typeface="宋体" panose="02010600030101010101" pitchFamily="2" charset="-122"/>
              </a:rPr>
              <a:t>1</a:t>
            </a:r>
            <a:r>
              <a:rPr lang="en-US" altLang="zh-CN" sz="1800" kern="100" dirty="0">
                <a:effectLst/>
                <a:latin typeface="Arial" panose="020B0604020202020204" pitchFamily="34" charset="0"/>
                <a:ea typeface="宋体" panose="02010600030101010101" pitchFamily="2" charset="-122"/>
              </a:rPr>
              <a:t> to 5 contained 0, 0.5, 1, 1, and 1 </a:t>
            </a:r>
            <a:r>
              <a:rPr lang="en-US" altLang="zh-CN" sz="1800" kern="100" dirty="0" err="1">
                <a:effectLst/>
                <a:latin typeface="Arial" panose="020B0604020202020204" pitchFamily="34" charset="0"/>
                <a:ea typeface="宋体" panose="02010600030101010101" pitchFamily="2" charset="-122"/>
              </a:rPr>
              <a:t>μM</a:t>
            </a:r>
            <a:r>
              <a:rPr lang="en-US" altLang="zh-CN" sz="1800" kern="100" dirty="0">
                <a:effectLst/>
                <a:latin typeface="Arial" panose="020B0604020202020204" pitchFamily="34" charset="0"/>
                <a:ea typeface="宋体" panose="02010600030101010101" pitchFamily="2" charset="-122"/>
              </a:rPr>
              <a:t> His</a:t>
            </a:r>
            <a:r>
              <a:rPr lang="en-US" altLang="zh-CN" sz="1800" kern="100" baseline="-25000" dirty="0">
                <a:effectLst/>
                <a:latin typeface="Arial" panose="020B0604020202020204" pitchFamily="34" charset="0"/>
                <a:ea typeface="宋体" panose="02010600030101010101" pitchFamily="2" charset="-122"/>
              </a:rPr>
              <a:t>6</a:t>
            </a:r>
            <a:r>
              <a:rPr lang="en-US" altLang="zh-CN" sz="1800" kern="100" dirty="0">
                <a:effectLst/>
                <a:latin typeface="Arial" panose="020B0604020202020204" pitchFamily="34" charset="0"/>
                <a:ea typeface="宋体" panose="02010600030101010101" pitchFamily="2" charset="-122"/>
              </a:rPr>
              <a:t>-GlnR respectively. A 200-fold excess of </a:t>
            </a:r>
            <a:r>
              <a:rPr lang="en-US" altLang="zh-CN" sz="1800" kern="100" dirty="0" err="1">
                <a:effectLst/>
                <a:latin typeface="Arial" panose="020B0604020202020204" pitchFamily="34" charset="0"/>
                <a:ea typeface="宋体" panose="02010600030101010101" pitchFamily="2" charset="-122"/>
              </a:rPr>
              <a:t>unlabelled</a:t>
            </a:r>
            <a:r>
              <a:rPr lang="en-US" altLang="zh-CN" sz="1800" kern="100" dirty="0">
                <a:effectLst/>
                <a:latin typeface="Arial" panose="020B0604020202020204" pitchFamily="34" charset="0"/>
                <a:ea typeface="宋体" panose="02010600030101010101" pitchFamily="2" charset="-122"/>
              </a:rPr>
              <a:t> specific probe (lanes 4) or nonspecific competitor DNA (Probe 1) (lanes 5) was used in competition assays. 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42291746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2</TotalTime>
  <Words>82</Words>
  <Application>Microsoft Office PowerPoint</Application>
  <PresentationFormat>宽屏</PresentationFormat>
  <Paragraphs>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等线</vt:lpstr>
      <vt:lpstr>等线 Light</vt:lpstr>
      <vt:lpstr>Arial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王 天舒</dc:creator>
  <cp:lastModifiedBy>王 天舒</cp:lastModifiedBy>
  <cp:revision>3</cp:revision>
  <dcterms:created xsi:type="dcterms:W3CDTF">2022-10-27T12:50:39Z</dcterms:created>
  <dcterms:modified xsi:type="dcterms:W3CDTF">2022-10-27T13:53:31Z</dcterms:modified>
</cp:coreProperties>
</file>